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137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5945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1237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727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3415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835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590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67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0103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928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052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461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82DD84-7E5A-4310-BCFE-FC26FFFE3CA7}" type="datetimeFigureOut">
              <a:rPr kumimoji="1" lang="ja-JP" altLang="en-US" smtClean="0"/>
              <a:t>2020/10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2729E-C08D-40EB-9ED7-78D4DF3B0C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0135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xmlns="" id="{93BED769-3D78-4ACE-B21E-AA58752DFD9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5661"/>
            <a:ext cx="9144000" cy="615926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AEBD528D-2644-44A1-9FAE-F0399B60AF15}"/>
              </a:ext>
            </a:extLst>
          </p:cNvPr>
          <p:cNvSpPr txBox="1"/>
          <p:nvPr/>
        </p:nvSpPr>
        <p:spPr>
          <a:xfrm>
            <a:off x="451319" y="6374921"/>
            <a:ext cx="82413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/>
              <a:t>Supplemental Figure S3. </a:t>
            </a:r>
            <a:r>
              <a:rPr lang="en-US" altLang="ja-JP" sz="1100" dirty="0"/>
              <a:t>Comparison of the average nucleotide identity (ANI) and the alignment percentages (AP). Upper comparison: ANI, Lower comparison: AP. Conservation filtering: minimum similarity fraction 0.8, minimum length fraction 0.8.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156422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43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iigata Bacteriology</dc:creator>
  <cp:lastModifiedBy>Tateishi</cp:lastModifiedBy>
  <cp:revision>3</cp:revision>
  <dcterms:created xsi:type="dcterms:W3CDTF">2020-10-04T01:32:17Z</dcterms:created>
  <dcterms:modified xsi:type="dcterms:W3CDTF">2020-10-04T02:00:36Z</dcterms:modified>
</cp:coreProperties>
</file>